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CDCEC0-A31E-4A86-8CB7-95DD723EE35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E0EE2F-7AB3-4FEE-AD8B-1FB3B1B2B4B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5D0C4-DC49-4F23-BA4A-CC60C510B0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76B42-B6E9-44D2-8B19-8CDEFF02EE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4667C-540C-4E38-A683-3503973C67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E99E0-D7A2-4B46-97DA-CE3905552F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CE778-7366-4BE0-B326-007B310F7D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F2F2A-895E-448F-A2BB-89B4702E8E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87500-A2D8-4D2E-A303-ACDB722F12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3FED7-8D43-48D2-BD31-3D2D9F235C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771BD-687F-49C1-A66E-0B82FC2920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4BD5A-1DB3-49F3-9CA1-DB1A14C33B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9B2CF-FEE2-4C2C-8853-0715B6B46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105D2-4036-455E-AB9E-5FD9839B96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7D0666-6C22-4855-ACAF-3E3999B7862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66"/>
          <p:cNvGrpSpPr/>
          <p:nvPr/>
        </p:nvGrpSpPr>
        <p:grpSpPr>
          <a:xfrm>
            <a:off x="52560" y="716040"/>
            <a:ext cx="2969280" cy="2796480"/>
            <a:chOff x="52560" y="716040"/>
            <a:chExt cx="2969280" cy="279648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tretch/>
          </p:blipFill>
          <p:spPr>
            <a:xfrm>
              <a:off x="52560" y="716040"/>
              <a:ext cx="2879640" cy="2759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テキスト ボックス 3"/>
            <p:cNvSpPr/>
            <p:nvPr/>
          </p:nvSpPr>
          <p:spPr>
            <a:xfrm>
              <a:off x="473400" y="763920"/>
              <a:ext cx="959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C) GTL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テキスト ボックス 4"/>
            <p:cNvSpPr/>
            <p:nvPr/>
          </p:nvSpPr>
          <p:spPr>
            <a:xfrm>
              <a:off x="1992600" y="230076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80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" name="グループ化 28"/>
            <p:cNvGrpSpPr/>
            <p:nvPr/>
          </p:nvGrpSpPr>
          <p:grpSpPr>
            <a:xfrm>
              <a:off x="64080" y="1796760"/>
              <a:ext cx="1878840" cy="1715760"/>
              <a:chOff x="64080" y="1796760"/>
              <a:chExt cx="1878840" cy="1715760"/>
            </a:xfrm>
          </p:grpSpPr>
          <p:grpSp>
            <p:nvGrpSpPr>
              <p:cNvPr id="53" name="グループ化 27"/>
              <p:cNvGrpSpPr/>
              <p:nvPr/>
            </p:nvGrpSpPr>
            <p:grpSpPr>
              <a:xfrm>
                <a:off x="64080" y="1796760"/>
                <a:ext cx="347760" cy="529920"/>
                <a:chOff x="64080" y="1796760"/>
                <a:chExt cx="347760" cy="529920"/>
              </a:xfrm>
            </p:grpSpPr>
            <p:sp>
              <p:nvSpPr>
                <p:cNvPr id="54" name="正方形/長方形 21"/>
                <p:cNvSpPr/>
                <p:nvPr/>
              </p:nvSpPr>
              <p:spPr>
                <a:xfrm>
                  <a:off x="179640" y="1796760"/>
                  <a:ext cx="194040" cy="529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テキスト ボックス 24"/>
                <p:cNvSpPr/>
                <p:nvPr/>
              </p:nvSpPr>
              <p:spPr>
                <a:xfrm flipV="1">
                  <a:off x="64080" y="186372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" name="グループ化 26"/>
              <p:cNvGrpSpPr/>
              <p:nvPr/>
            </p:nvGrpSpPr>
            <p:grpSpPr>
              <a:xfrm>
                <a:off x="1414080" y="3164760"/>
                <a:ext cx="528840" cy="347760"/>
                <a:chOff x="1414080" y="3164760"/>
                <a:chExt cx="528840" cy="347760"/>
              </a:xfrm>
            </p:grpSpPr>
            <p:sp>
              <p:nvSpPr>
                <p:cNvPr id="57" name="正方形/長方形 22"/>
                <p:cNvSpPr/>
                <p:nvPr/>
              </p:nvSpPr>
              <p:spPr>
                <a:xfrm rot="5400000">
                  <a:off x="1584000" y="3049200"/>
                  <a:ext cx="198360" cy="5194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テキスト ボックス 25"/>
                <p:cNvSpPr/>
                <p:nvPr/>
              </p:nvSpPr>
              <p:spPr>
                <a:xfrm flipV="1" rot="5400000">
                  <a:off x="1487520" y="309096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59" name="グループ化 65"/>
          <p:cNvGrpSpPr/>
          <p:nvPr/>
        </p:nvGrpSpPr>
        <p:grpSpPr>
          <a:xfrm>
            <a:off x="2987640" y="3363840"/>
            <a:ext cx="2879640" cy="2796840"/>
            <a:chOff x="2987640" y="3363840"/>
            <a:chExt cx="2879640" cy="2796840"/>
          </a:xfrm>
        </p:grpSpPr>
        <p:pic>
          <p:nvPicPr>
            <p:cNvPr id="60" name="Picture 3" descr=""/>
            <p:cNvPicPr/>
            <p:nvPr/>
          </p:nvPicPr>
          <p:blipFill>
            <a:blip r:embed="rId2"/>
            <a:stretch/>
          </p:blipFill>
          <p:spPr>
            <a:xfrm>
              <a:off x="2987640" y="3363840"/>
              <a:ext cx="2879640" cy="276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テキスト ボックス 6"/>
            <p:cNvSpPr/>
            <p:nvPr/>
          </p:nvSpPr>
          <p:spPr>
            <a:xfrm>
              <a:off x="3432960" y="3428280"/>
              <a:ext cx="1003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G) PEG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テキスト ボックス 7"/>
            <p:cNvSpPr/>
            <p:nvPr/>
          </p:nvSpPr>
          <p:spPr>
            <a:xfrm>
              <a:off x="4695480" y="494892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55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" name="グループ化 29"/>
            <p:cNvGrpSpPr/>
            <p:nvPr/>
          </p:nvGrpSpPr>
          <p:grpSpPr>
            <a:xfrm>
              <a:off x="3023640" y="4444920"/>
              <a:ext cx="1878840" cy="1715760"/>
              <a:chOff x="3023640" y="4444920"/>
              <a:chExt cx="1878840" cy="1715760"/>
            </a:xfrm>
          </p:grpSpPr>
          <p:grpSp>
            <p:nvGrpSpPr>
              <p:cNvPr id="64" name="グループ化 27"/>
              <p:cNvGrpSpPr/>
              <p:nvPr/>
            </p:nvGrpSpPr>
            <p:grpSpPr>
              <a:xfrm>
                <a:off x="3023640" y="4444920"/>
                <a:ext cx="347760" cy="529920"/>
                <a:chOff x="3023640" y="4444920"/>
                <a:chExt cx="347760" cy="529920"/>
              </a:xfrm>
            </p:grpSpPr>
            <p:sp>
              <p:nvSpPr>
                <p:cNvPr id="65" name="正方形/長方形 34"/>
                <p:cNvSpPr/>
                <p:nvPr/>
              </p:nvSpPr>
              <p:spPr>
                <a:xfrm>
                  <a:off x="3139560" y="4444920"/>
                  <a:ext cx="193680" cy="529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テキスト ボックス 35"/>
                <p:cNvSpPr/>
                <p:nvPr/>
              </p:nvSpPr>
              <p:spPr>
                <a:xfrm flipV="1">
                  <a:off x="3023640" y="451188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7" name="グループ化 26"/>
              <p:cNvGrpSpPr/>
              <p:nvPr/>
            </p:nvGrpSpPr>
            <p:grpSpPr>
              <a:xfrm>
                <a:off x="4373280" y="5812920"/>
                <a:ext cx="529200" cy="347760"/>
                <a:chOff x="4373280" y="5812920"/>
                <a:chExt cx="529200" cy="347760"/>
              </a:xfrm>
            </p:grpSpPr>
            <p:sp>
              <p:nvSpPr>
                <p:cNvPr id="68" name="正方形/長方形 32"/>
                <p:cNvSpPr/>
                <p:nvPr/>
              </p:nvSpPr>
              <p:spPr>
                <a:xfrm rot="5400000">
                  <a:off x="4543920" y="5697720"/>
                  <a:ext cx="198360" cy="518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テキスト ボックス 33"/>
                <p:cNvSpPr/>
                <p:nvPr/>
              </p:nvSpPr>
              <p:spPr>
                <a:xfrm flipV="1" rot="5400000">
                  <a:off x="4446720" y="573912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70" name="グループ化 64"/>
          <p:cNvGrpSpPr/>
          <p:nvPr/>
        </p:nvGrpSpPr>
        <p:grpSpPr>
          <a:xfrm>
            <a:off x="2987640" y="716040"/>
            <a:ext cx="2879640" cy="2796480"/>
            <a:chOff x="2987640" y="716040"/>
            <a:chExt cx="2879640" cy="2796480"/>
          </a:xfrm>
        </p:grpSpPr>
        <p:pic>
          <p:nvPicPr>
            <p:cNvPr id="71" name="Picture 4" descr=""/>
            <p:cNvPicPr/>
            <p:nvPr/>
          </p:nvPicPr>
          <p:blipFill>
            <a:blip r:embed="rId3"/>
            <a:stretch/>
          </p:blipFill>
          <p:spPr>
            <a:xfrm>
              <a:off x="2988360" y="716040"/>
              <a:ext cx="2878920" cy="2759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テキスト ボックス 9"/>
            <p:cNvSpPr/>
            <p:nvPr/>
          </p:nvSpPr>
          <p:spPr>
            <a:xfrm>
              <a:off x="3426840" y="763920"/>
              <a:ext cx="1102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D) ZDBF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テキスト ボックス 10"/>
            <p:cNvSpPr/>
            <p:nvPr/>
          </p:nvSpPr>
          <p:spPr>
            <a:xfrm>
              <a:off x="4559040" y="228960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74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グループ化 36"/>
            <p:cNvGrpSpPr/>
            <p:nvPr/>
          </p:nvGrpSpPr>
          <p:grpSpPr>
            <a:xfrm>
              <a:off x="2987640" y="1796760"/>
              <a:ext cx="1878480" cy="1715760"/>
              <a:chOff x="2987640" y="1796760"/>
              <a:chExt cx="1878480" cy="1715760"/>
            </a:xfrm>
          </p:grpSpPr>
          <p:grpSp>
            <p:nvGrpSpPr>
              <p:cNvPr id="75" name="グループ化 27"/>
              <p:cNvGrpSpPr/>
              <p:nvPr/>
            </p:nvGrpSpPr>
            <p:grpSpPr>
              <a:xfrm>
                <a:off x="2987640" y="1796760"/>
                <a:ext cx="347760" cy="529920"/>
                <a:chOff x="2987640" y="1796760"/>
                <a:chExt cx="347760" cy="529920"/>
              </a:xfrm>
            </p:grpSpPr>
            <p:sp>
              <p:nvSpPr>
                <p:cNvPr id="76" name="正方形/長方形 41"/>
                <p:cNvSpPr/>
                <p:nvPr/>
              </p:nvSpPr>
              <p:spPr>
                <a:xfrm>
                  <a:off x="3103560" y="1796760"/>
                  <a:ext cx="193680" cy="529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テキスト ボックス 42"/>
                <p:cNvSpPr/>
                <p:nvPr/>
              </p:nvSpPr>
              <p:spPr>
                <a:xfrm flipV="1">
                  <a:off x="2987640" y="186372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8" name="グループ化 26"/>
              <p:cNvGrpSpPr/>
              <p:nvPr/>
            </p:nvGrpSpPr>
            <p:grpSpPr>
              <a:xfrm>
                <a:off x="4326840" y="3164760"/>
                <a:ext cx="539280" cy="347760"/>
                <a:chOff x="4326840" y="3164760"/>
                <a:chExt cx="539280" cy="347760"/>
              </a:xfrm>
            </p:grpSpPr>
            <p:sp>
              <p:nvSpPr>
                <p:cNvPr id="79" name="正方形/長方形 39"/>
                <p:cNvSpPr/>
                <p:nvPr/>
              </p:nvSpPr>
              <p:spPr>
                <a:xfrm rot="5400000">
                  <a:off x="4497120" y="3039120"/>
                  <a:ext cx="198360" cy="5392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テキスト ボックス 40"/>
                <p:cNvSpPr/>
                <p:nvPr/>
              </p:nvSpPr>
              <p:spPr>
                <a:xfrm flipV="1" rot="5400000">
                  <a:off x="4411080" y="309096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81" name="グループ化 67"/>
          <p:cNvGrpSpPr/>
          <p:nvPr/>
        </p:nvGrpSpPr>
        <p:grpSpPr>
          <a:xfrm>
            <a:off x="52560" y="3406680"/>
            <a:ext cx="2879640" cy="2759040"/>
            <a:chOff x="52560" y="3406680"/>
            <a:chExt cx="2879640" cy="2759040"/>
          </a:xfrm>
        </p:grpSpPr>
        <p:pic>
          <p:nvPicPr>
            <p:cNvPr id="82" name="Picture 5" descr=""/>
            <p:cNvPicPr/>
            <p:nvPr/>
          </p:nvPicPr>
          <p:blipFill>
            <a:blip r:embed="rId4"/>
            <a:stretch/>
          </p:blipFill>
          <p:spPr>
            <a:xfrm>
              <a:off x="52560" y="3406680"/>
              <a:ext cx="2879640" cy="275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テキスト ボックス 13"/>
            <p:cNvSpPr/>
            <p:nvPr/>
          </p:nvSpPr>
          <p:spPr>
            <a:xfrm>
              <a:off x="475200" y="3477960"/>
              <a:ext cx="835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F) ZA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テキスト ボックス 14"/>
            <p:cNvSpPr/>
            <p:nvPr/>
          </p:nvSpPr>
          <p:spPr>
            <a:xfrm>
              <a:off x="1776960" y="494244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89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5" name="グループ化 43"/>
            <p:cNvGrpSpPr/>
            <p:nvPr/>
          </p:nvGrpSpPr>
          <p:grpSpPr>
            <a:xfrm>
              <a:off x="61920" y="4445640"/>
              <a:ext cx="1878840" cy="1715040"/>
              <a:chOff x="61920" y="4445640"/>
              <a:chExt cx="1878840" cy="1715040"/>
            </a:xfrm>
          </p:grpSpPr>
          <p:grpSp>
            <p:nvGrpSpPr>
              <p:cNvPr id="86" name="グループ化 27"/>
              <p:cNvGrpSpPr/>
              <p:nvPr/>
            </p:nvGrpSpPr>
            <p:grpSpPr>
              <a:xfrm>
                <a:off x="61920" y="4445640"/>
                <a:ext cx="347760" cy="529560"/>
                <a:chOff x="61920" y="4445640"/>
                <a:chExt cx="347760" cy="529560"/>
              </a:xfrm>
            </p:grpSpPr>
            <p:sp>
              <p:nvSpPr>
                <p:cNvPr id="87" name="正方形/長方形 48"/>
                <p:cNvSpPr/>
                <p:nvPr/>
              </p:nvSpPr>
              <p:spPr>
                <a:xfrm>
                  <a:off x="177840" y="4445640"/>
                  <a:ext cx="193680" cy="529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テキスト ボックス 49"/>
                <p:cNvSpPr/>
                <p:nvPr/>
              </p:nvSpPr>
              <p:spPr>
                <a:xfrm flipV="1">
                  <a:off x="61920" y="451296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9" name="グループ化 26"/>
              <p:cNvGrpSpPr/>
              <p:nvPr/>
            </p:nvGrpSpPr>
            <p:grpSpPr>
              <a:xfrm>
                <a:off x="1411560" y="5812920"/>
                <a:ext cx="529200" cy="347760"/>
                <a:chOff x="1411560" y="5812920"/>
                <a:chExt cx="529200" cy="347760"/>
              </a:xfrm>
            </p:grpSpPr>
            <p:sp>
              <p:nvSpPr>
                <p:cNvPr id="90" name="正方形/長方形 46"/>
                <p:cNvSpPr/>
                <p:nvPr/>
              </p:nvSpPr>
              <p:spPr>
                <a:xfrm rot="5400000">
                  <a:off x="1582200" y="5697720"/>
                  <a:ext cx="198360" cy="518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テキスト ボックス 47"/>
                <p:cNvSpPr/>
                <p:nvPr/>
              </p:nvSpPr>
              <p:spPr>
                <a:xfrm flipV="1" rot="5400000">
                  <a:off x="1485000" y="573912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92" name="グループ化 68"/>
          <p:cNvGrpSpPr/>
          <p:nvPr/>
        </p:nvGrpSpPr>
        <p:grpSpPr>
          <a:xfrm>
            <a:off x="5896080" y="3365640"/>
            <a:ext cx="2894040" cy="2795040"/>
            <a:chOff x="5896080" y="3365640"/>
            <a:chExt cx="2894040" cy="2795040"/>
          </a:xfrm>
        </p:grpSpPr>
        <p:pic>
          <p:nvPicPr>
            <p:cNvPr id="93" name="Picture 6" descr=""/>
            <p:cNvPicPr/>
            <p:nvPr/>
          </p:nvPicPr>
          <p:blipFill>
            <a:blip r:embed="rId5"/>
            <a:stretch/>
          </p:blipFill>
          <p:spPr>
            <a:xfrm>
              <a:off x="5911200" y="3365640"/>
              <a:ext cx="2878920" cy="275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テキスト ボックス 16"/>
            <p:cNvSpPr/>
            <p:nvPr/>
          </p:nvSpPr>
          <p:spPr>
            <a:xfrm>
              <a:off x="6308280" y="3429000"/>
              <a:ext cx="1153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H) SNRP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テキスト ボックス 17"/>
            <p:cNvSpPr/>
            <p:nvPr/>
          </p:nvSpPr>
          <p:spPr>
            <a:xfrm>
              <a:off x="7715520" y="497088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44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6" name="グループ化 50"/>
            <p:cNvGrpSpPr/>
            <p:nvPr/>
          </p:nvGrpSpPr>
          <p:grpSpPr>
            <a:xfrm>
              <a:off x="5896080" y="4445280"/>
              <a:ext cx="1878480" cy="1715400"/>
              <a:chOff x="5896080" y="4445280"/>
              <a:chExt cx="1878480" cy="1715400"/>
            </a:xfrm>
          </p:grpSpPr>
          <p:grpSp>
            <p:nvGrpSpPr>
              <p:cNvPr id="97" name="グループ化 27"/>
              <p:cNvGrpSpPr/>
              <p:nvPr/>
            </p:nvGrpSpPr>
            <p:grpSpPr>
              <a:xfrm>
                <a:off x="5896080" y="4445280"/>
                <a:ext cx="347760" cy="529920"/>
                <a:chOff x="5896080" y="4445280"/>
                <a:chExt cx="347760" cy="529920"/>
              </a:xfrm>
            </p:grpSpPr>
            <p:sp>
              <p:nvSpPr>
                <p:cNvPr id="98" name="正方形/長方形 55"/>
                <p:cNvSpPr/>
                <p:nvPr/>
              </p:nvSpPr>
              <p:spPr>
                <a:xfrm>
                  <a:off x="6012000" y="4445280"/>
                  <a:ext cx="193680" cy="529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テキスト ボックス 56"/>
                <p:cNvSpPr/>
                <p:nvPr/>
              </p:nvSpPr>
              <p:spPr>
                <a:xfrm flipV="1">
                  <a:off x="5896080" y="451260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0" name="グループ化 26"/>
              <p:cNvGrpSpPr/>
              <p:nvPr/>
            </p:nvGrpSpPr>
            <p:grpSpPr>
              <a:xfrm>
                <a:off x="7235280" y="5812920"/>
                <a:ext cx="539280" cy="347760"/>
                <a:chOff x="7235280" y="5812920"/>
                <a:chExt cx="539280" cy="347760"/>
              </a:xfrm>
            </p:grpSpPr>
            <p:sp>
              <p:nvSpPr>
                <p:cNvPr id="101" name="正方形/長方形 53"/>
                <p:cNvSpPr/>
                <p:nvPr/>
              </p:nvSpPr>
              <p:spPr>
                <a:xfrm rot="5400000">
                  <a:off x="7405560" y="5687280"/>
                  <a:ext cx="198360" cy="5392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テキスト ボックス 54"/>
                <p:cNvSpPr/>
                <p:nvPr/>
              </p:nvSpPr>
              <p:spPr>
                <a:xfrm flipV="1" rot="5400000">
                  <a:off x="7319520" y="573912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03" name="グループ化 69"/>
          <p:cNvGrpSpPr/>
          <p:nvPr/>
        </p:nvGrpSpPr>
        <p:grpSpPr>
          <a:xfrm>
            <a:off x="5896080" y="717480"/>
            <a:ext cx="2887560" cy="2795040"/>
            <a:chOff x="5896080" y="717480"/>
            <a:chExt cx="2887560" cy="2795040"/>
          </a:xfrm>
        </p:grpSpPr>
        <p:pic>
          <p:nvPicPr>
            <p:cNvPr id="104" name="Picture 7" descr=""/>
            <p:cNvPicPr/>
            <p:nvPr/>
          </p:nvPicPr>
          <p:blipFill>
            <a:blip r:embed="rId6"/>
            <a:stretch/>
          </p:blipFill>
          <p:spPr>
            <a:xfrm>
              <a:off x="5903640" y="717480"/>
              <a:ext cx="2880000" cy="275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テキスト ボックス 20"/>
            <p:cNvSpPr/>
            <p:nvPr/>
          </p:nvSpPr>
          <p:spPr>
            <a:xfrm>
              <a:off x="6315840" y="764280"/>
              <a:ext cx="861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E) LIT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テキスト ボックス 21"/>
            <p:cNvSpPr/>
            <p:nvPr/>
          </p:nvSpPr>
          <p:spPr>
            <a:xfrm>
              <a:off x="7500600" y="2301840"/>
              <a:ext cx="1029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R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r>
                <a:rPr b="0" lang="ja-JP" sz="1600" spc="-1" strike="noStrike">
                  <a:solidFill>
                    <a:srgbClr val="000000"/>
                  </a:solidFill>
                  <a:latin typeface="Calibri"/>
                </a:rPr>
                <a:t>＝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0.63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7" name="グループ化 57"/>
            <p:cNvGrpSpPr/>
            <p:nvPr/>
          </p:nvGrpSpPr>
          <p:grpSpPr>
            <a:xfrm>
              <a:off x="5896080" y="1797120"/>
              <a:ext cx="1879200" cy="1715400"/>
              <a:chOff x="5896080" y="1797120"/>
              <a:chExt cx="1879200" cy="1715400"/>
            </a:xfrm>
          </p:grpSpPr>
          <p:grpSp>
            <p:nvGrpSpPr>
              <p:cNvPr id="108" name="グループ化 27"/>
              <p:cNvGrpSpPr/>
              <p:nvPr/>
            </p:nvGrpSpPr>
            <p:grpSpPr>
              <a:xfrm>
                <a:off x="5896080" y="1797120"/>
                <a:ext cx="347760" cy="529920"/>
                <a:chOff x="5896080" y="1797120"/>
                <a:chExt cx="347760" cy="529920"/>
              </a:xfrm>
            </p:grpSpPr>
            <p:sp>
              <p:nvSpPr>
                <p:cNvPr id="109" name="正方形/長方形 62"/>
                <p:cNvSpPr/>
                <p:nvPr/>
              </p:nvSpPr>
              <p:spPr>
                <a:xfrm>
                  <a:off x="6012000" y="1797120"/>
                  <a:ext cx="193680" cy="529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テキスト ボックス 63"/>
                <p:cNvSpPr/>
                <p:nvPr/>
              </p:nvSpPr>
              <p:spPr>
                <a:xfrm flipV="1">
                  <a:off x="5896080" y="1864440"/>
                  <a:ext cx="347760" cy="303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BP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1" name="グループ化 26"/>
              <p:cNvGrpSpPr/>
              <p:nvPr/>
            </p:nvGrpSpPr>
            <p:grpSpPr>
              <a:xfrm>
                <a:off x="7245720" y="3164760"/>
                <a:ext cx="529560" cy="347760"/>
                <a:chOff x="7245720" y="3164760"/>
                <a:chExt cx="529560" cy="347760"/>
              </a:xfrm>
            </p:grpSpPr>
            <p:sp>
              <p:nvSpPr>
                <p:cNvPr id="112" name="正方形/長方形 60"/>
                <p:cNvSpPr/>
                <p:nvPr/>
              </p:nvSpPr>
              <p:spPr>
                <a:xfrm rot="5400000">
                  <a:off x="7416360" y="3049200"/>
                  <a:ext cx="198360" cy="5191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テキスト ボックス 61"/>
                <p:cNvSpPr/>
                <p:nvPr/>
              </p:nvSpPr>
              <p:spPr>
                <a:xfrm flipV="1" rot="5400000">
                  <a:off x="7319160" y="3090960"/>
                  <a:ext cx="347760" cy="495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Calibri"/>
                    </a:rPr>
                    <a:t>COBR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2T01:58:45Z</dcterms:created>
  <dc:creator>Arima</dc:creator>
  <dc:description/>
  <dc:language>en-US</dc:language>
  <cp:lastModifiedBy>Arima</cp:lastModifiedBy>
  <dcterms:modified xsi:type="dcterms:W3CDTF">2012-02-22T02:14:06Z</dcterms:modified>
  <cp:revision>2</cp:revision>
  <dc:subject/>
  <dc:title>スライド 1</dc:title>
</cp:coreProperties>
</file>